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57" r:id="rId2"/>
    <p:sldId id="294" r:id="rId3"/>
    <p:sldId id="296" r:id="rId4"/>
    <p:sldId id="297" r:id="rId5"/>
    <p:sldId id="298" r:id="rId6"/>
    <p:sldId id="299" r:id="rId7"/>
    <p:sldId id="300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53"/>
    <p:restoredTop sz="94586"/>
  </p:normalViewPr>
  <p:slideViewPr>
    <p:cSldViewPr snapToGrid="0" snapToObjects="1">
      <p:cViewPr varScale="1">
        <p:scale>
          <a:sx n="108" d="100"/>
          <a:sy n="108" d="100"/>
        </p:scale>
        <p:origin x="1080" y="20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B1E11F-188D-8147-BD86-E61A2C71D294}" type="datetimeFigureOut">
              <a:rPr lang="en-US" smtClean="0"/>
              <a:t>2/19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24AF81-F42A-1C4C-81E6-E26385BC0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471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aseline="0" dirty="0"/>
              <a:t>What opportunities does digital data recording provide that is not possible with paper-based diaries?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aseline="0" dirty="0"/>
              <a:t>Can digital data monitoring provide new ways to detect in real-time which women are likely to require intervention?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aseline="0" dirty="0"/>
              <a:t>How can we quantify observations from individual patients in order to deduce useful insights?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aseline="0" dirty="0"/>
              <a:t>How can we relate these insights to the end point of pregnancy?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D5A4FA-AFB7-4353-A08D-EC2ACBA3225D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06085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Clinician interfa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DA5BB4-12E9-4322-AA05-EC9BCE73D6C7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428076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odel</a:t>
            </a:r>
            <a:r>
              <a:rPr lang="en-US" baseline="0" dirty="0"/>
              <a:t> day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91F1E32-3342-4416-9363-02A65957677B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45166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hyperlink" Target="http://ouh.oxnet.nhs.uk/Resources/Picture%20Library/OUH_FT_NHS_logo_process.jpg" TargetMode="Externa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9DB57-9F36-374E-AF07-514504E5AC7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097C9-A733-6E48-AD6D-6508C10558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9DB57-9F36-374E-AF07-514504E5AC7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097C9-A733-6E48-AD6D-6508C10558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9DB57-9F36-374E-AF07-514504E5AC7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097C9-A733-6E48-AD6D-6508C10558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9DB57-9F36-374E-AF07-514504E5AC7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097C9-A733-6E48-AD6D-6508C10558A3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2" descr="Picture">
            <a:hlinkClick r:id="rId2" invalidUrl="http://ouh.oxnet.nhs.uk/Resources/Picture Library/OUH_FT_NHS_logo_process.jpg"/>
          </p:cNvPr>
          <p:cNvPicPr>
            <a:picLocks noChangeAspect="1" noChangeArrowheads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1630" y="91219"/>
            <a:ext cx="3143672" cy="4175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9DB57-9F36-374E-AF07-514504E5AC7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097C9-A733-6E48-AD6D-6508C10558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9DB57-9F36-374E-AF07-514504E5AC7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097C9-A733-6E48-AD6D-6508C10558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9DB57-9F36-374E-AF07-514504E5AC7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097C9-A733-6E48-AD6D-6508C10558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9DB57-9F36-374E-AF07-514504E5AC7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097C9-A733-6E48-AD6D-6508C10558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9DB57-9F36-374E-AF07-514504E5AC7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097C9-A733-6E48-AD6D-6508C10558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9DB57-9F36-374E-AF07-514504E5AC7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097C9-A733-6E48-AD6D-6508C10558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9DB57-9F36-374E-AF07-514504E5AC7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097C9-A733-6E48-AD6D-6508C10558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89DB57-9F36-374E-AF07-514504E5AC7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9097C9-A733-6E48-AD6D-6508C10558A3}" type="slidenum">
              <a:rPr lang="en-US" smtClean="0"/>
              <a:t>‹#›</a:t>
            </a:fld>
            <a:endParaRPr lang="en-US"/>
          </a:p>
        </p:txBody>
      </p:sp>
      <p:sp>
        <p:nvSpPr>
          <p:cNvPr id="7" name="Rectangle 6"/>
          <p:cNvSpPr/>
          <p:nvPr userDrawn="1"/>
        </p:nvSpPr>
        <p:spPr>
          <a:xfrm>
            <a:off x="0" y="6227998"/>
            <a:ext cx="9144000" cy="641759"/>
          </a:xfrm>
          <a:prstGeom prst="rect">
            <a:avLst/>
          </a:prstGeom>
          <a:solidFill>
            <a:srgbClr val="002147"/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189"/>
            <a:endParaRPr lang="en-GB">
              <a:solidFill>
                <a:prstClr val="white"/>
              </a:solidFill>
            </a:endParaRPr>
          </a:p>
        </p:txBody>
      </p:sp>
      <p:pic>
        <p:nvPicPr>
          <p:cNvPr id="8" name="Picture 4" descr="http://www.ox.ac.uk/images/hi_res/2258_ox_brand_blue_pos_rect.png"/>
          <p:cNvPicPr>
            <a:picLocks noChangeAspect="1" noChangeArrowheads="1"/>
          </p:cNvPicPr>
          <p:nvPr userDrawn="1"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369" y="6282209"/>
            <a:ext cx="1657371" cy="509833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384581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hyperlink" Target="http://www.google.co.uk/url?sa=i&amp;rct=j&amp;q=wifi+symbol&amp;source=images&amp;cd=&amp;cad=rja&amp;docid=eK2aCwICBiXngM&amp;tbnid=RdzEL6psDFImzM:&amp;ved=0CAUQjRw&amp;url=http://www.clker.com/clipart-free-wifi-sign.html&amp;ei=9ehCUcP-KqbX0QXNsYDIBQ&amp;bvm=bv.43828540,d.d2k&amp;psig=AFQjCNGSEBg5sFMSoq3fvExjSGLCmtW_sQ&amp;ust=1363425883732497" TargetMode="External"/><Relationship Id="rId13" Type="http://schemas.openxmlformats.org/officeDocument/2006/relationships/image" Target="../media/image15.png"/><Relationship Id="rId3" Type="http://schemas.openxmlformats.org/officeDocument/2006/relationships/image" Target="../media/image6.jpeg"/><Relationship Id="rId7" Type="http://schemas.openxmlformats.org/officeDocument/2006/relationships/image" Target="../media/image10.png"/><Relationship Id="rId12" Type="http://schemas.openxmlformats.org/officeDocument/2006/relationships/image" Target="../media/image14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openxmlformats.org/officeDocument/2006/relationships/image" Target="../media/image13.emf"/><Relationship Id="rId5" Type="http://schemas.openxmlformats.org/officeDocument/2006/relationships/image" Target="../media/image8.png"/><Relationship Id="rId10" Type="http://schemas.openxmlformats.org/officeDocument/2006/relationships/image" Target="../media/image12.jpeg"/><Relationship Id="rId4" Type="http://schemas.openxmlformats.org/officeDocument/2006/relationships/image" Target="../media/image7.png"/><Relationship Id="rId9" Type="http://schemas.openxmlformats.org/officeDocument/2006/relationships/image" Target="../media/image11.png"/><Relationship Id="rId14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hyperlink" Target="http://www.google.co.uk/url?sa=i&amp;rct=j&amp;q=wifi+symbol&amp;source=images&amp;cd=&amp;cad=rja&amp;docid=eK2aCwICBiXngM&amp;tbnid=RdzEL6psDFImzM:&amp;ved=0CAUQjRw&amp;url=http://www.clker.com/clipart-free-wifi-sign.html&amp;ei=9ehCUcP-KqbX0QXNsYDIBQ&amp;bvm=bv.43828540,d.d2k&amp;psig=AFQjCNGSEBg5sFMSoq3fvExjSGLCmtW_sQ&amp;ust=1363425883732497" TargetMode="External"/><Relationship Id="rId13" Type="http://schemas.openxmlformats.org/officeDocument/2006/relationships/image" Target="../media/image15.png"/><Relationship Id="rId3" Type="http://schemas.openxmlformats.org/officeDocument/2006/relationships/image" Target="../media/image6.jpeg"/><Relationship Id="rId7" Type="http://schemas.openxmlformats.org/officeDocument/2006/relationships/image" Target="../media/image10.png"/><Relationship Id="rId12" Type="http://schemas.openxmlformats.org/officeDocument/2006/relationships/image" Target="../media/image14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openxmlformats.org/officeDocument/2006/relationships/image" Target="../media/image13.emf"/><Relationship Id="rId5" Type="http://schemas.openxmlformats.org/officeDocument/2006/relationships/image" Target="../media/image8.png"/><Relationship Id="rId10" Type="http://schemas.openxmlformats.org/officeDocument/2006/relationships/image" Target="../media/image12.jpeg"/><Relationship Id="rId4" Type="http://schemas.openxmlformats.org/officeDocument/2006/relationships/image" Target="../media/image7.png"/><Relationship Id="rId9" Type="http://schemas.openxmlformats.org/officeDocument/2006/relationships/image" Target="../media/image11.png"/><Relationship Id="rId1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 descr="C:\Users\newc3929\Dropbox\GDm-Health (RCT)\Isobel\Photo 21-06-2013 14 11 14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6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7" r="1" b="13680"/>
          <a:stretch/>
        </p:blipFill>
        <p:spPr bwMode="auto">
          <a:xfrm>
            <a:off x="1" y="1"/>
            <a:ext cx="9158875" cy="47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82359" y="4879081"/>
            <a:ext cx="7056452" cy="819007"/>
          </a:xfrm>
        </p:spPr>
        <p:txBody>
          <a:bodyPr>
            <a:noAutofit/>
          </a:bodyPr>
          <a:lstStyle/>
          <a:p>
            <a:pPr algn="l"/>
            <a:r>
              <a:rPr lang="en-GB" sz="1800" b="1" dirty="0"/>
              <a:t>A randomised controlled trial to compare the efficacy of a smartphone-based blood glucose management system with standard clinic care in women with gestational diabetes</a:t>
            </a:r>
            <a:endParaRPr lang="en-GB" sz="1800" dirty="0"/>
          </a:p>
        </p:txBody>
      </p:sp>
      <p:sp>
        <p:nvSpPr>
          <p:cNvPr id="9" name="Subtitle 2"/>
          <p:cNvSpPr txBox="1">
            <a:spLocks/>
          </p:cNvSpPr>
          <p:nvPr/>
        </p:nvSpPr>
        <p:spPr>
          <a:xfrm>
            <a:off x="1547664" y="6326184"/>
            <a:ext cx="4392488" cy="295232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2400" dirty="0">
              <a:solidFill>
                <a:srgbClr val="002147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6001" y="4970521"/>
            <a:ext cx="1762080" cy="607319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356616" y="5698088"/>
            <a:ext cx="829360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hort Title: Technology for Remote Evaluation and Treatment of GDM: TREAT-GDM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2009974" y="6211669"/>
            <a:ext cx="686543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dirty="0">
                <a:solidFill>
                  <a:schemeClr val="bg1"/>
                </a:solidFill>
              </a:rPr>
              <a:t>Dr Lucy Mackillop, Consultant Obstetric Physician, Honorary Senior Clinical Lecturer, Oxford University Hospitals NHS Foundation Trust</a:t>
            </a:r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801672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93"/>
          <p:cNvSpPr txBox="1"/>
          <p:nvPr/>
        </p:nvSpPr>
        <p:spPr>
          <a:xfrm>
            <a:off x="4129942" y="1419028"/>
            <a:ext cx="4906591" cy="2060138"/>
          </a:xfrm>
          <a:prstGeom prst="roundRect">
            <a:avLst/>
          </a:prstGeom>
          <a:ln w="28575"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600"/>
              </a:spcAft>
            </a:pPr>
            <a:r>
              <a:rPr lang="en-US" sz="2000" b="1" dirty="0">
                <a:solidFill>
                  <a:prstClr val="black"/>
                </a:solidFill>
              </a:rPr>
              <a:t>Patients use the </a:t>
            </a:r>
            <a:r>
              <a:rPr lang="en-US" sz="2000" b="1" dirty="0">
                <a:solidFill>
                  <a:srgbClr val="FF3399"/>
                </a:solidFill>
              </a:rPr>
              <a:t>phone app </a:t>
            </a:r>
            <a:r>
              <a:rPr lang="en-US" sz="2000" b="1" dirty="0">
                <a:solidFill>
                  <a:prstClr val="black"/>
                </a:solidFill>
              </a:rPr>
              <a:t>to:</a:t>
            </a:r>
          </a:p>
          <a:p>
            <a:pPr marL="342891" indent="-342891">
              <a:spcAft>
                <a:spcPts val="600"/>
              </a:spcAft>
              <a:buFont typeface="Arial"/>
              <a:buChar char="•"/>
            </a:pPr>
            <a:r>
              <a:rPr lang="en-US" sz="2000" i="1" dirty="0">
                <a:solidFill>
                  <a:prstClr val="black"/>
                </a:solidFill>
              </a:rPr>
              <a:t>Annotate</a:t>
            </a:r>
            <a:r>
              <a:rPr lang="en-US" sz="2000" dirty="0">
                <a:solidFill>
                  <a:prstClr val="black"/>
                </a:solidFill>
              </a:rPr>
              <a:t> SMBG data with meal tags, medication doses and other comments</a:t>
            </a:r>
          </a:p>
          <a:p>
            <a:pPr marL="342891" indent="-342891">
              <a:spcAft>
                <a:spcPts val="600"/>
              </a:spcAft>
              <a:buFont typeface="Arial"/>
              <a:buChar char="•"/>
            </a:pPr>
            <a:r>
              <a:rPr lang="en-US" sz="2000" i="1" dirty="0">
                <a:solidFill>
                  <a:prstClr val="black"/>
                </a:solidFill>
              </a:rPr>
              <a:t>Review</a:t>
            </a:r>
            <a:r>
              <a:rPr lang="en-US" sz="2000" dirty="0">
                <a:solidFill>
                  <a:prstClr val="black"/>
                </a:solidFill>
              </a:rPr>
              <a:t> previous data graphically</a:t>
            </a:r>
          </a:p>
          <a:p>
            <a:pPr marL="342891" indent="-342891">
              <a:spcAft>
                <a:spcPts val="600"/>
              </a:spcAft>
              <a:buFont typeface="Arial"/>
              <a:buChar char="•"/>
            </a:pPr>
            <a:r>
              <a:rPr lang="en-US" sz="2000" i="1" dirty="0">
                <a:solidFill>
                  <a:prstClr val="black"/>
                </a:solidFill>
              </a:rPr>
              <a:t>Request</a:t>
            </a:r>
            <a:r>
              <a:rPr lang="en-US" sz="2000" dirty="0">
                <a:solidFill>
                  <a:prstClr val="black"/>
                </a:solidFill>
              </a:rPr>
              <a:t> a call back from the midwife</a:t>
            </a:r>
          </a:p>
        </p:txBody>
      </p:sp>
      <p:sp>
        <p:nvSpPr>
          <p:cNvPr id="5" name="Rectangle 4"/>
          <p:cNvSpPr/>
          <p:nvPr/>
        </p:nvSpPr>
        <p:spPr>
          <a:xfrm>
            <a:off x="4201988" y="6322368"/>
            <a:ext cx="47625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1200" dirty="0" err="1">
                <a:solidFill>
                  <a:schemeClr val="bg1"/>
                </a:solidFill>
                <a:latin typeface="Helvetica Neue"/>
              </a:rPr>
              <a:t>Mackillop</a:t>
            </a:r>
            <a:r>
              <a:rPr lang="en-GB" sz="1200" dirty="0">
                <a:solidFill>
                  <a:schemeClr val="bg1"/>
                </a:solidFill>
                <a:latin typeface="Helvetica Neue"/>
              </a:rPr>
              <a:t> et al. J Diabetes </a:t>
            </a:r>
            <a:r>
              <a:rPr lang="en-GB" sz="1200" dirty="0" err="1">
                <a:solidFill>
                  <a:schemeClr val="bg1"/>
                </a:solidFill>
                <a:latin typeface="Helvetica Neue"/>
              </a:rPr>
              <a:t>Sci</a:t>
            </a:r>
            <a:r>
              <a:rPr lang="en-GB" sz="1200" dirty="0">
                <a:solidFill>
                  <a:schemeClr val="bg1"/>
                </a:solidFill>
                <a:latin typeface="Helvetica Neue"/>
              </a:rPr>
              <a:t> </a:t>
            </a:r>
            <a:r>
              <a:rPr lang="en-GB" sz="1200" dirty="0" err="1">
                <a:solidFill>
                  <a:schemeClr val="bg1"/>
                </a:solidFill>
                <a:latin typeface="Helvetica Neue"/>
              </a:rPr>
              <a:t>Technol</a:t>
            </a:r>
            <a:r>
              <a:rPr lang="en-GB" sz="1200" dirty="0">
                <a:solidFill>
                  <a:schemeClr val="bg1"/>
                </a:solidFill>
                <a:latin typeface="Helvetica Neue"/>
              </a:rPr>
              <a:t> 2014; 8 (6): 1105-1114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593966" y="395071"/>
            <a:ext cx="4046941" cy="5361277"/>
            <a:chOff x="0" y="1688141"/>
            <a:chExt cx="9584595" cy="11111289"/>
          </a:xfrm>
        </p:grpSpPr>
        <p:grpSp>
          <p:nvGrpSpPr>
            <p:cNvPr id="8" name="Group 7"/>
            <p:cNvGrpSpPr/>
            <p:nvPr/>
          </p:nvGrpSpPr>
          <p:grpSpPr>
            <a:xfrm>
              <a:off x="0" y="8851361"/>
              <a:ext cx="1999597" cy="2253302"/>
              <a:chOff x="0" y="8851361"/>
              <a:chExt cx="1999597" cy="2253302"/>
            </a:xfrm>
          </p:grpSpPr>
          <p:pic>
            <p:nvPicPr>
              <p:cNvPr id="40" name="Picture 39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8851361"/>
                <a:ext cx="1999597" cy="225330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1" name="Picture 40" descr="http://mentalhealthcop.files.wordpress.com/2012/02/nhs1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640600">
                <a:off x="714415" y="10439008"/>
                <a:ext cx="446012" cy="2955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9" name="TextBox 16"/>
            <p:cNvSpPr txBox="1"/>
            <p:nvPr/>
          </p:nvSpPr>
          <p:spPr>
            <a:xfrm>
              <a:off x="2772170" y="6292864"/>
              <a:ext cx="3228568" cy="92972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Bluetooth </a:t>
              </a:r>
              <a:endParaRPr lang="en-GB" sz="9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Glucose Meter Accessory</a:t>
              </a:r>
              <a:endParaRPr lang="en-GB" sz="9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(</a:t>
              </a:r>
              <a:r>
                <a:rPr lang="en-US" sz="900" kern="1200" dirty="0" err="1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Polymap</a:t>
              </a: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 LLC)</a:t>
              </a:r>
              <a:endParaRPr lang="en-GB" sz="9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0" name="TextBox 17"/>
            <p:cNvSpPr txBox="1"/>
            <p:nvPr/>
          </p:nvSpPr>
          <p:spPr>
            <a:xfrm>
              <a:off x="264054" y="6460849"/>
              <a:ext cx="1867700" cy="92973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OneTouch </a:t>
              </a:r>
              <a:r>
                <a:rPr lang="en-US" sz="900" kern="1200" dirty="0" err="1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UltraEasy</a:t>
              </a:r>
              <a:endParaRPr lang="en-GB" sz="5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(</a:t>
              </a:r>
              <a:r>
                <a:rPr lang="en-US" sz="900" kern="1200" dirty="0" err="1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Lifescan</a:t>
              </a: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 Inc.)</a:t>
              </a:r>
              <a:endParaRPr lang="en-GB" sz="5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1" name="TextBox 78"/>
            <p:cNvSpPr txBox="1"/>
            <p:nvPr/>
          </p:nvSpPr>
          <p:spPr>
            <a:xfrm>
              <a:off x="6218773" y="6601160"/>
              <a:ext cx="1709147" cy="64910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Android mobile phone with app</a:t>
              </a:r>
              <a:endParaRPr lang="en-GB" sz="500" dirty="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>
              <a:off x="4930773" y="4856092"/>
              <a:ext cx="1095076" cy="0"/>
            </a:xfrm>
            <a:prstGeom prst="straightConnector1">
              <a:avLst/>
            </a:prstGeom>
            <a:ln w="38100"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3" name="Picture 12" descr="http://windows8installation.com/wp-content/uploads/2012/03/BlueTooth.pn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92107" y="4568060"/>
              <a:ext cx="551383" cy="5513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Rectangle 13"/>
            <p:cNvSpPr/>
            <p:nvPr/>
          </p:nvSpPr>
          <p:spPr>
            <a:xfrm>
              <a:off x="4903834" y="8960338"/>
              <a:ext cx="2016041" cy="761354"/>
            </a:xfrm>
            <a:prstGeom prst="rect">
              <a:avLst/>
            </a:prstGeom>
            <a:noFill/>
          </p:spPr>
          <p:txBody>
            <a:bodyPr wrap="square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7F7F7F"/>
                  </a:solidFill>
                  <a:effectLst/>
                  <a:latin typeface="Helvetica Neue"/>
                  <a:ea typeface="Times New Roman"/>
                  <a:cs typeface="Helvetica Neue"/>
                </a:rPr>
                <a:t>TEXT</a:t>
              </a:r>
              <a:endParaRPr lang="en-GB" sz="5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7F7F7F"/>
                  </a:solidFill>
                  <a:effectLst/>
                  <a:latin typeface="Helvetica Neue"/>
                  <a:ea typeface="Times New Roman"/>
                  <a:cs typeface="Helvetica Neue"/>
                </a:rPr>
                <a:t>MESSAGES</a:t>
              </a:r>
              <a:endParaRPr lang="en-GB" sz="500" dirty="0">
                <a:effectLst/>
                <a:latin typeface="Times New Roman"/>
                <a:ea typeface="Times New Roman"/>
              </a:endParaRPr>
            </a:p>
          </p:txBody>
        </p:sp>
        <p:grpSp>
          <p:nvGrpSpPr>
            <p:cNvPr id="15" name="Group 14"/>
            <p:cNvGrpSpPr/>
            <p:nvPr/>
          </p:nvGrpSpPr>
          <p:grpSpPr>
            <a:xfrm>
              <a:off x="5669502" y="8784976"/>
              <a:ext cx="3699069" cy="4014454"/>
              <a:chOff x="5669502" y="8784976"/>
              <a:chExt cx="3699069" cy="4014454"/>
            </a:xfrm>
          </p:grpSpPr>
          <p:grpSp>
            <p:nvGrpSpPr>
              <p:cNvPr id="35" name="Group 34"/>
              <p:cNvGrpSpPr>
                <a:grpSpLocks noChangeAspect="1"/>
              </p:cNvGrpSpPr>
              <p:nvPr/>
            </p:nvGrpSpPr>
            <p:grpSpPr>
              <a:xfrm>
                <a:off x="5669502" y="9688172"/>
                <a:ext cx="3074648" cy="3111258"/>
                <a:chOff x="5669502" y="9688172"/>
                <a:chExt cx="3501361" cy="3543049"/>
              </a:xfrm>
            </p:grpSpPr>
            <p:pic>
              <p:nvPicPr>
                <p:cNvPr id="38" name="Picture 37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clrChange>
                    <a:clrFrom>
                      <a:srgbClr val="FEFEFE"/>
                    </a:clrFrom>
                    <a:clrTo>
                      <a:srgbClr val="FEFEFE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021" t="27019" r="1123" b="20301"/>
                <a:stretch/>
              </p:blipFill>
              <p:spPr>
                <a:xfrm>
                  <a:off x="6625411" y="9688172"/>
                  <a:ext cx="2545452" cy="3543049"/>
                </a:xfrm>
                <a:prstGeom prst="rect">
                  <a:avLst/>
                </a:prstGeom>
              </p:spPr>
            </p:pic>
            <p:sp>
              <p:nvSpPr>
                <p:cNvPr id="39" name="Rectangle 38"/>
                <p:cNvSpPr/>
                <p:nvPr/>
              </p:nvSpPr>
              <p:spPr>
                <a:xfrm>
                  <a:off x="5669502" y="9688172"/>
                  <a:ext cx="1800200" cy="32403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n-GB"/>
                </a:p>
              </p:txBody>
            </p:sp>
          </p:grpSp>
          <p:sp>
            <p:nvSpPr>
              <p:cNvPr id="36" name="TextBox 74"/>
              <p:cNvSpPr txBox="1"/>
              <p:nvPr/>
            </p:nvSpPr>
            <p:spPr>
              <a:xfrm>
                <a:off x="6942530" y="9688172"/>
                <a:ext cx="1276536" cy="400110"/>
              </a:xfrm>
              <a:custGeom>
                <a:avLst/>
                <a:gdLst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162003 w 1067650"/>
                  <a:gd name="connsiteY6" fmla="*/ 972000 h 972000"/>
                  <a:gd name="connsiteX7" fmla="*/ 0 w 1067650"/>
                  <a:gd name="connsiteY7" fmla="*/ 809997 h 972000"/>
                  <a:gd name="connsiteX8" fmla="*/ 0 w 1067650"/>
                  <a:gd name="connsiteY8" fmla="*/ 162003 h 972000"/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220060 w 1067650"/>
                  <a:gd name="connsiteY6" fmla="*/ 884915 h 972000"/>
                  <a:gd name="connsiteX7" fmla="*/ 0 w 1067650"/>
                  <a:gd name="connsiteY7" fmla="*/ 809997 h 972000"/>
                  <a:gd name="connsiteX8" fmla="*/ 0 w 1067650"/>
                  <a:gd name="connsiteY8" fmla="*/ 162003 h 972000"/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132975 w 1067650"/>
                  <a:gd name="connsiteY6" fmla="*/ 957486 h 972000"/>
                  <a:gd name="connsiteX7" fmla="*/ 0 w 1067650"/>
                  <a:gd name="connsiteY7" fmla="*/ 809997 h 972000"/>
                  <a:gd name="connsiteX8" fmla="*/ 0 w 1067650"/>
                  <a:gd name="connsiteY8" fmla="*/ 162003 h 972000"/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132975 w 1067650"/>
                  <a:gd name="connsiteY6" fmla="*/ 957486 h 972000"/>
                  <a:gd name="connsiteX7" fmla="*/ 87085 w 1067650"/>
                  <a:gd name="connsiteY7" fmla="*/ 780969 h 972000"/>
                  <a:gd name="connsiteX8" fmla="*/ 0 w 1067650"/>
                  <a:gd name="connsiteY8" fmla="*/ 162003 h 972000"/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132975 w 1067650"/>
                  <a:gd name="connsiteY6" fmla="*/ 957486 h 972000"/>
                  <a:gd name="connsiteX7" fmla="*/ 87085 w 1067650"/>
                  <a:gd name="connsiteY7" fmla="*/ 780969 h 972000"/>
                  <a:gd name="connsiteX8" fmla="*/ 0 w 1067650"/>
                  <a:gd name="connsiteY8" fmla="*/ 162003 h 972000"/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132975 w 1067650"/>
                  <a:gd name="connsiteY6" fmla="*/ 957486 h 972000"/>
                  <a:gd name="connsiteX7" fmla="*/ 87085 w 1067650"/>
                  <a:gd name="connsiteY7" fmla="*/ 780969 h 972000"/>
                  <a:gd name="connsiteX8" fmla="*/ 0 w 1067650"/>
                  <a:gd name="connsiteY8" fmla="*/ 162003 h 972000"/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176518 w 1067650"/>
                  <a:gd name="connsiteY6" fmla="*/ 899429 h 972000"/>
                  <a:gd name="connsiteX7" fmla="*/ 87085 w 1067650"/>
                  <a:gd name="connsiteY7" fmla="*/ 780969 h 972000"/>
                  <a:gd name="connsiteX8" fmla="*/ 0 w 1067650"/>
                  <a:gd name="connsiteY8" fmla="*/ 162003 h 972000"/>
                  <a:gd name="connsiteX0" fmla="*/ 0 w 1067650"/>
                  <a:gd name="connsiteY0" fmla="*/ 162003 h 975838"/>
                  <a:gd name="connsiteX1" fmla="*/ 162003 w 1067650"/>
                  <a:gd name="connsiteY1" fmla="*/ 0 h 975838"/>
                  <a:gd name="connsiteX2" fmla="*/ 905647 w 1067650"/>
                  <a:gd name="connsiteY2" fmla="*/ 0 h 975838"/>
                  <a:gd name="connsiteX3" fmla="*/ 1067650 w 1067650"/>
                  <a:gd name="connsiteY3" fmla="*/ 162003 h 975838"/>
                  <a:gd name="connsiteX4" fmla="*/ 1067650 w 1067650"/>
                  <a:gd name="connsiteY4" fmla="*/ 809997 h 975838"/>
                  <a:gd name="connsiteX5" fmla="*/ 905647 w 1067650"/>
                  <a:gd name="connsiteY5" fmla="*/ 972000 h 975838"/>
                  <a:gd name="connsiteX6" fmla="*/ 176518 w 1067650"/>
                  <a:gd name="connsiteY6" fmla="*/ 899429 h 975838"/>
                  <a:gd name="connsiteX7" fmla="*/ 87085 w 1067650"/>
                  <a:gd name="connsiteY7" fmla="*/ 780969 h 975838"/>
                  <a:gd name="connsiteX8" fmla="*/ 0 w 1067650"/>
                  <a:gd name="connsiteY8" fmla="*/ 162003 h 9758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1067650" h="975838">
                    <a:moveTo>
                      <a:pt x="0" y="162003"/>
                    </a:moveTo>
                    <a:cubicBezTo>
                      <a:pt x="0" y="72531"/>
                      <a:pt x="72531" y="0"/>
                      <a:pt x="162003" y="0"/>
                    </a:cubicBezTo>
                    <a:lnTo>
                      <a:pt x="905647" y="0"/>
                    </a:lnTo>
                    <a:cubicBezTo>
                      <a:pt x="995119" y="0"/>
                      <a:pt x="1067650" y="72531"/>
                      <a:pt x="1067650" y="162003"/>
                    </a:cubicBezTo>
                    <a:lnTo>
                      <a:pt x="1067650" y="809997"/>
                    </a:lnTo>
                    <a:cubicBezTo>
                      <a:pt x="1067650" y="899469"/>
                      <a:pt x="995119" y="972000"/>
                      <a:pt x="905647" y="972000"/>
                    </a:cubicBezTo>
                    <a:cubicBezTo>
                      <a:pt x="657766" y="972000"/>
                      <a:pt x="264742" y="1001029"/>
                      <a:pt x="176518" y="899429"/>
                    </a:cubicBezTo>
                    <a:cubicBezTo>
                      <a:pt x="87046" y="899429"/>
                      <a:pt x="188685" y="797870"/>
                      <a:pt x="87085" y="780969"/>
                    </a:cubicBezTo>
                    <a:cubicBezTo>
                      <a:pt x="29028" y="632704"/>
                      <a:pt x="29028" y="368325"/>
                      <a:pt x="0" y="162003"/>
                    </a:cubicBezTo>
                    <a:close/>
                  </a:path>
                </a:pathLst>
              </a:custGeom>
              <a:ln w="28575">
                <a:noFill/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wrap="square" rtlCol="0">
                <a:noAutofit/>
              </a:bodyPr>
              <a:lstStyle/>
              <a:p>
                <a:endParaRPr lang="en-GB"/>
              </a:p>
            </p:txBody>
          </p:sp>
          <p:pic>
            <p:nvPicPr>
              <p:cNvPr id="37" name="Picture 36" descr="C:\Documents and Settings\Oliver\My Documents\mHealth\Publications\DiabetesTechnology2012\GDm-Health\nurse_256_edited.png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7424571" y="8784976"/>
                <a:ext cx="1944000" cy="1944000"/>
              </a:xfrm>
              <a:prstGeom prst="rect">
                <a:avLst/>
              </a:prstGeom>
              <a:noFill/>
            </p:spPr>
          </p:pic>
        </p:grpSp>
        <p:grpSp>
          <p:nvGrpSpPr>
            <p:cNvPr id="16" name="Group 15"/>
            <p:cNvGrpSpPr/>
            <p:nvPr/>
          </p:nvGrpSpPr>
          <p:grpSpPr>
            <a:xfrm>
              <a:off x="347898" y="2798898"/>
              <a:ext cx="4848548" cy="4184639"/>
              <a:chOff x="347898" y="2798898"/>
              <a:chExt cx="4848548" cy="4184639"/>
            </a:xfrm>
          </p:grpSpPr>
          <p:pic>
            <p:nvPicPr>
              <p:cNvPr id="33" name="Picture 32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7898" y="2798898"/>
                <a:ext cx="4848548" cy="4184639"/>
              </a:xfrm>
              <a:prstGeom prst="rect">
                <a:avLst/>
              </a:prstGeom>
            </p:spPr>
          </p:pic>
          <p:sp>
            <p:nvSpPr>
              <p:cNvPr id="34" name="Rectangle 33"/>
              <p:cNvSpPr/>
              <p:nvPr/>
            </p:nvSpPr>
            <p:spPr>
              <a:xfrm>
                <a:off x="1163998" y="2798898"/>
                <a:ext cx="207080" cy="4010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/>
              </a:p>
            </p:txBody>
          </p:sp>
        </p:grpSp>
        <p:cxnSp>
          <p:nvCxnSpPr>
            <p:cNvPr id="17" name="Straight Arrow Connector 16"/>
            <p:cNvCxnSpPr/>
            <p:nvPr/>
          </p:nvCxnSpPr>
          <p:spPr>
            <a:xfrm flipH="1">
              <a:off x="1735723" y="10578085"/>
              <a:ext cx="4466020" cy="0"/>
            </a:xfrm>
            <a:prstGeom prst="straightConnector1">
              <a:avLst/>
            </a:prstGeom>
            <a:ln w="28575">
              <a:solidFill>
                <a:schemeClr val="bg1">
                  <a:lumMod val="75000"/>
                </a:schemeClr>
              </a:solidFill>
              <a:prstDash val="sysDash"/>
              <a:headEnd type="arrow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 flipH="1">
              <a:off x="1308701" y="8329210"/>
              <a:ext cx="5693635" cy="0"/>
            </a:xfrm>
            <a:prstGeom prst="straightConnector1">
              <a:avLst/>
            </a:prstGeom>
            <a:ln w="28575">
              <a:solidFill>
                <a:schemeClr val="bg1">
                  <a:lumMod val="75000"/>
                </a:schemeClr>
              </a:solidFill>
              <a:prstDash val="sys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>
              <a:off x="6999011" y="7926578"/>
              <a:ext cx="0" cy="402632"/>
            </a:xfrm>
            <a:prstGeom prst="straightConnector1">
              <a:avLst/>
            </a:prstGeom>
            <a:ln w="28575">
              <a:solidFill>
                <a:schemeClr val="bg1">
                  <a:lumMod val="75000"/>
                </a:schemeClr>
              </a:solidFill>
              <a:prstDash val="sys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/>
            <p:cNvCxnSpPr/>
            <p:nvPr/>
          </p:nvCxnSpPr>
          <p:spPr>
            <a:xfrm>
              <a:off x="1308701" y="8329210"/>
              <a:ext cx="0" cy="455766"/>
            </a:xfrm>
            <a:prstGeom prst="straightConnector1">
              <a:avLst/>
            </a:prstGeom>
            <a:ln w="28575">
              <a:solidFill>
                <a:schemeClr val="bg1">
                  <a:lumMod val="75000"/>
                </a:schemeClr>
              </a:solidFill>
              <a:prstDash val="sysDash"/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 flipH="1">
              <a:off x="7152111" y="7926578"/>
              <a:ext cx="0" cy="2036517"/>
            </a:xfrm>
            <a:prstGeom prst="straightConnector1">
              <a:avLst/>
            </a:prstGeom>
            <a:ln w="28575">
              <a:solidFill>
                <a:schemeClr val="bg1">
                  <a:lumMod val="75000"/>
                </a:schemeClr>
              </a:solidFill>
              <a:prstDash val="sysDash"/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" name="Group 21"/>
            <p:cNvGrpSpPr/>
            <p:nvPr/>
          </p:nvGrpSpPr>
          <p:grpSpPr>
            <a:xfrm>
              <a:off x="3895963" y="10328459"/>
              <a:ext cx="1668407" cy="632601"/>
              <a:chOff x="3895963" y="10328459"/>
              <a:chExt cx="1668407" cy="632601"/>
            </a:xfrm>
          </p:grpSpPr>
          <p:sp>
            <p:nvSpPr>
              <p:cNvPr id="30" name="Rectangle 29"/>
              <p:cNvSpPr/>
              <p:nvPr/>
            </p:nvSpPr>
            <p:spPr>
              <a:xfrm>
                <a:off x="3895963" y="10340312"/>
                <a:ext cx="829119" cy="4336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4373248" y="10328459"/>
                <a:ext cx="1191122" cy="63260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sz="900" b="1" kern="1200" dirty="0">
                    <a:solidFill>
                      <a:srgbClr val="7F7F7F"/>
                    </a:solidFill>
                    <a:effectLst/>
                    <a:latin typeface="Helvetica Neue"/>
                    <a:ea typeface="Times New Roman"/>
                    <a:cs typeface="Helvetica Neue"/>
                  </a:rPr>
                  <a:t>Wi-Fi</a:t>
                </a:r>
                <a:endParaRPr lang="en-GB" sz="500" dirty="0">
                  <a:effectLst/>
                  <a:latin typeface="Times New Roman"/>
                  <a:ea typeface="Times New Roman"/>
                </a:endParaRPr>
              </a:p>
            </p:txBody>
          </p:sp>
          <p:pic>
            <p:nvPicPr>
              <p:cNvPr id="32" name="Picture 31" descr="http://www.clker.com/cliparts/9/p/9/h/t/P/free-wifi-sign-hi.png">
                <a:hlinkClick r:id="rId8"/>
              </p:cNvPr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8909"/>
              <a:stretch/>
            </p:blipFill>
            <p:spPr bwMode="auto">
              <a:xfrm>
                <a:off x="3895964" y="10403326"/>
                <a:ext cx="416662" cy="37067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23" name="Picture 22" descr="http://desertluxuryrealty.com/wp-content/uploads/2012/08/email-letter-icon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99" t="14730" r="12979" b="18243"/>
            <a:stretch/>
          </p:blipFill>
          <p:spPr bwMode="auto">
            <a:xfrm>
              <a:off x="6758179" y="9032556"/>
              <a:ext cx="720080" cy="5165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4" name="Rectangle 23"/>
            <p:cNvSpPr/>
            <p:nvPr/>
          </p:nvSpPr>
          <p:spPr>
            <a:xfrm>
              <a:off x="3548832" y="7992701"/>
              <a:ext cx="1859101" cy="7613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900" b="1" kern="1200" dirty="0">
                  <a:solidFill>
                    <a:srgbClr val="7F7F7F"/>
                  </a:solidFill>
                  <a:effectLst/>
                  <a:latin typeface="Helvetica Neue"/>
                  <a:ea typeface="Times New Roman"/>
                  <a:cs typeface="Helvetica Neue"/>
                </a:rPr>
                <a:t>MOBILE</a:t>
              </a:r>
              <a:endParaRPr lang="en-GB" sz="4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US" sz="900" b="1" kern="1200" dirty="0">
                  <a:solidFill>
                    <a:srgbClr val="7F7F7F"/>
                  </a:solidFill>
                  <a:effectLst/>
                  <a:latin typeface="Helvetica Neue"/>
                  <a:ea typeface="Times New Roman"/>
                  <a:cs typeface="Helvetica Neue"/>
                </a:rPr>
                <a:t>INTERNET</a:t>
              </a:r>
              <a:endParaRPr lang="en-GB" sz="400" dirty="0">
                <a:effectLst/>
                <a:latin typeface="Times New Roman"/>
                <a:ea typeface="Times New Roman"/>
              </a:endParaRPr>
            </a:p>
          </p:txBody>
        </p:sp>
        <p:pic>
          <p:nvPicPr>
            <p:cNvPr id="25" name="Picture 24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99356" y="7952436"/>
              <a:ext cx="1108575" cy="15000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86818" y="3108960"/>
              <a:ext cx="2160240" cy="3462182"/>
            </a:xfrm>
            <a:prstGeom prst="rect">
              <a:avLst/>
            </a:prstGeom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27" name="Picture 26" descr="C:\Documents and Settings\Oliver\My Documents\mHealth\Publications\DiabetesTechnology2012\GDm-Health\pregnant_256.png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7558306" y="1688141"/>
              <a:ext cx="2026289" cy="1944000"/>
            </a:xfrm>
            <a:prstGeom prst="rect">
              <a:avLst/>
            </a:prstGeom>
            <a:noFill/>
          </p:spPr>
        </p:pic>
        <p:pic>
          <p:nvPicPr>
            <p:cNvPr id="28" name="Picture 27" descr="E:\dcim\2013-09-12_04-28-54.png"/>
            <p:cNvPicPr>
              <a:picLocks noChangeAspect="1" noChangeArrowheads="1"/>
            </p:cNvPicPr>
            <p:nvPr/>
          </p:nvPicPr>
          <p:blipFill>
            <a:blip r:embed="rId14"/>
            <a:srcRect t="4906"/>
            <a:stretch>
              <a:fillRect/>
            </a:stretch>
          </p:blipFill>
          <p:spPr bwMode="auto">
            <a:xfrm rot="60000">
              <a:off x="6288369" y="3542354"/>
              <a:ext cx="1620000" cy="2310794"/>
            </a:xfrm>
            <a:prstGeom prst="rect">
              <a:avLst/>
            </a:prstGeom>
            <a:noFill/>
          </p:spPr>
        </p:pic>
      </p:grpSp>
      <p:sp>
        <p:nvSpPr>
          <p:cNvPr id="43" name="TextBox 74"/>
          <p:cNvSpPr txBox="1"/>
          <p:nvPr/>
        </p:nvSpPr>
        <p:spPr>
          <a:xfrm>
            <a:off x="4549694" y="3600467"/>
            <a:ext cx="3796516" cy="2400657"/>
          </a:xfrm>
          <a:prstGeom prst="roundRect">
            <a:avLst/>
          </a:prstGeom>
          <a:ln w="28575"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600"/>
              </a:spcAft>
            </a:pPr>
            <a:r>
              <a:rPr lang="en-US" sz="2000" b="1" dirty="0">
                <a:solidFill>
                  <a:prstClr val="black"/>
                </a:solidFill>
              </a:rPr>
              <a:t>Healthcare professionals use the </a:t>
            </a:r>
            <a:r>
              <a:rPr lang="en-US" sz="2000" b="1" dirty="0">
                <a:solidFill>
                  <a:srgbClr val="FF3399"/>
                </a:solidFill>
              </a:rPr>
              <a:t>website</a:t>
            </a:r>
            <a:r>
              <a:rPr lang="en-US" sz="2000" b="1" dirty="0">
                <a:solidFill>
                  <a:prstClr val="black"/>
                </a:solidFill>
              </a:rPr>
              <a:t> to:</a:t>
            </a:r>
          </a:p>
          <a:p>
            <a:pPr marL="342891" indent="-342891">
              <a:spcAft>
                <a:spcPts val="600"/>
              </a:spcAft>
              <a:buFont typeface="Arial"/>
              <a:buChar char="•"/>
            </a:pPr>
            <a:r>
              <a:rPr lang="en-US" sz="2000" i="1" dirty="0">
                <a:solidFill>
                  <a:prstClr val="black"/>
                </a:solidFill>
              </a:rPr>
              <a:t>Review</a:t>
            </a:r>
            <a:r>
              <a:rPr lang="en-US" sz="2000" dirty="0">
                <a:solidFill>
                  <a:prstClr val="black"/>
                </a:solidFill>
              </a:rPr>
              <a:t> submitted data</a:t>
            </a:r>
          </a:p>
          <a:p>
            <a:pPr marL="342891" indent="-342891">
              <a:spcAft>
                <a:spcPts val="600"/>
              </a:spcAft>
              <a:buFont typeface="Arial"/>
              <a:buChar char="•"/>
            </a:pPr>
            <a:r>
              <a:rPr lang="en-US" sz="2000" i="1" dirty="0">
                <a:solidFill>
                  <a:prstClr val="black"/>
                </a:solidFill>
              </a:rPr>
              <a:t>Automatic prioritization </a:t>
            </a:r>
            <a:r>
              <a:rPr lang="en-US" sz="2000" dirty="0">
                <a:solidFill>
                  <a:prstClr val="black"/>
                </a:solidFill>
              </a:rPr>
              <a:t>of patients</a:t>
            </a:r>
          </a:p>
          <a:p>
            <a:pPr marL="342891" indent="-342891">
              <a:spcAft>
                <a:spcPts val="600"/>
              </a:spcAft>
              <a:buFont typeface="Arial"/>
              <a:buChar char="•"/>
            </a:pPr>
            <a:r>
              <a:rPr lang="en-US" sz="2000" i="1" dirty="0">
                <a:solidFill>
                  <a:prstClr val="black"/>
                </a:solidFill>
              </a:rPr>
              <a:t>Feedback</a:t>
            </a:r>
            <a:r>
              <a:rPr lang="en-US" sz="2000" dirty="0">
                <a:solidFill>
                  <a:prstClr val="black"/>
                </a:solidFill>
              </a:rPr>
              <a:t> via text messages</a:t>
            </a:r>
          </a:p>
        </p:txBody>
      </p:sp>
    </p:spTree>
    <p:extLst>
      <p:ext uri="{BB962C8B-B14F-4D97-AF65-F5344CB8AC3E}">
        <p14:creationId xmlns:p14="http://schemas.microsoft.com/office/powerpoint/2010/main" val="1681003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>
            <a:grpSpLocks noChangeAspect="1"/>
          </p:cNvGrpSpPr>
          <p:nvPr/>
        </p:nvGrpSpPr>
        <p:grpSpPr>
          <a:xfrm>
            <a:off x="21199" y="99738"/>
            <a:ext cx="8824404" cy="5423332"/>
            <a:chOff x="-3648076" y="-2038350"/>
            <a:chExt cx="14935200" cy="9178926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370" t="29048" r="3143" b="41334"/>
            <a:stretch/>
          </p:blipFill>
          <p:spPr bwMode="auto">
            <a:xfrm>
              <a:off x="-3343276" y="2190749"/>
              <a:ext cx="14516101" cy="29622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11" t="20347" r="2973" b="39398"/>
            <a:stretch/>
          </p:blipFill>
          <p:spPr bwMode="auto">
            <a:xfrm>
              <a:off x="-3216275" y="3114676"/>
              <a:ext cx="14439900" cy="402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2" name="Picture 4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323" t="68365" r="2703" b="15556"/>
            <a:stretch/>
          </p:blipFill>
          <p:spPr bwMode="auto">
            <a:xfrm>
              <a:off x="-3648076" y="582612"/>
              <a:ext cx="14935200" cy="16081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3" name="Picture 5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638" t="71334" r="2929" b="10650"/>
            <a:stretch/>
          </p:blipFill>
          <p:spPr bwMode="auto">
            <a:xfrm>
              <a:off x="-3559175" y="-1219200"/>
              <a:ext cx="14782800" cy="18018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5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638" t="56731" r="2929" b="36666"/>
            <a:stretch/>
          </p:blipFill>
          <p:spPr bwMode="auto">
            <a:xfrm>
              <a:off x="-3559175" y="-1866899"/>
              <a:ext cx="14782800" cy="66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5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638" t="51842" r="2929" b="46190"/>
            <a:stretch/>
          </p:blipFill>
          <p:spPr bwMode="auto">
            <a:xfrm>
              <a:off x="-3559175" y="-2038350"/>
              <a:ext cx="14782800" cy="1968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2" name="Rectangle 11"/>
          <p:cNvSpPr/>
          <p:nvPr/>
        </p:nvSpPr>
        <p:spPr>
          <a:xfrm>
            <a:off x="1704424" y="4157337"/>
            <a:ext cx="273667" cy="1080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189"/>
            <a:endParaRPr lang="en-GB">
              <a:solidFill>
                <a:prstClr val="white"/>
              </a:solidFill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7" cstate="print"/>
          <a:srcRect l="12646" t="93303" r="10091" b="1783"/>
          <a:stretch/>
        </p:blipFill>
        <p:spPr bwMode="auto">
          <a:xfrm>
            <a:off x="1003300" y="5524935"/>
            <a:ext cx="6223000" cy="3604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17925E6-9847-7644-A9AB-8298D225CC68}"/>
              </a:ext>
            </a:extLst>
          </p:cNvPr>
          <p:cNvSpPr txBox="1"/>
          <p:nvPr/>
        </p:nvSpPr>
        <p:spPr>
          <a:xfrm>
            <a:off x="5474525" y="238864"/>
            <a:ext cx="2752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/>
              <a:t>Clinician’s View</a:t>
            </a:r>
          </a:p>
        </p:txBody>
      </p:sp>
    </p:spTree>
    <p:extLst>
      <p:ext uri="{BB962C8B-B14F-4D97-AF65-F5344CB8AC3E}">
        <p14:creationId xmlns:p14="http://schemas.microsoft.com/office/powerpoint/2010/main" val="11842784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520" y="6624"/>
            <a:ext cx="8229600" cy="1143000"/>
          </a:xfrm>
        </p:spPr>
        <p:txBody>
          <a:bodyPr/>
          <a:lstStyle/>
          <a:p>
            <a:pPr algn="l"/>
            <a:r>
              <a:rPr lang="en-US" dirty="0"/>
              <a:t>Blood glucose diaries</a:t>
            </a:r>
          </a:p>
        </p:txBody>
      </p:sp>
      <p:pic>
        <p:nvPicPr>
          <p:cNvPr id="4" name="Picture 3" descr="WebGraphs_v2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1143000"/>
            <a:ext cx="4828714" cy="4892040"/>
          </a:xfrm>
          <a:prstGeom prst="rect">
            <a:avLst/>
          </a:prstGeom>
        </p:spPr>
      </p:pic>
      <p:sp>
        <p:nvSpPr>
          <p:cNvPr id="5" name="Content Placeholder 2"/>
          <p:cNvSpPr txBox="1">
            <a:spLocks/>
          </p:cNvSpPr>
          <p:nvPr/>
        </p:nvSpPr>
        <p:spPr>
          <a:xfrm>
            <a:off x="5381896" y="1143000"/>
            <a:ext cx="3431177" cy="550164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7" name="Content Placeholder 2"/>
          <p:cNvSpPr txBox="1">
            <a:spLocks/>
          </p:cNvSpPr>
          <p:nvPr/>
        </p:nvSpPr>
        <p:spPr>
          <a:xfrm>
            <a:off x="5381896" y="1143000"/>
            <a:ext cx="3431178" cy="42040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solidFill>
                  <a:prstClr val="black"/>
                </a:solidFill>
              </a:rPr>
              <a:t>Emphasis on pre- and postprandial readings</a:t>
            </a:r>
          </a:p>
          <a:p>
            <a:endParaRPr lang="en-US" dirty="0">
              <a:solidFill>
                <a:prstClr val="black"/>
              </a:solidFill>
            </a:endParaRPr>
          </a:p>
          <a:p>
            <a:endParaRPr lang="en-US" dirty="0">
              <a:solidFill>
                <a:prstClr val="black"/>
              </a:solidFill>
            </a:endParaRPr>
          </a:p>
          <a:p>
            <a:endParaRPr lang="en-US" dirty="0">
              <a:solidFill>
                <a:prstClr val="black"/>
              </a:solidFill>
            </a:endParaRPr>
          </a:p>
          <a:p>
            <a:endParaRPr lang="en-US" dirty="0">
              <a:solidFill>
                <a:prstClr val="black"/>
              </a:solidFill>
            </a:endParaRPr>
          </a:p>
          <a:p>
            <a:r>
              <a:rPr lang="en-US" dirty="0">
                <a:solidFill>
                  <a:prstClr val="black"/>
                </a:solidFill>
              </a:rPr>
              <a:t>Diurnal variations in blood glucose</a:t>
            </a:r>
          </a:p>
        </p:txBody>
      </p:sp>
    </p:spTree>
    <p:extLst>
      <p:ext uri="{BB962C8B-B14F-4D97-AF65-F5344CB8AC3E}">
        <p14:creationId xmlns:p14="http://schemas.microsoft.com/office/powerpoint/2010/main" val="10740943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3"/>
          <p:cNvPicPr>
            <a:picLocks noChangeAspect="1" noChangeArrowheads="1"/>
          </p:cNvPicPr>
          <p:nvPr/>
        </p:nvPicPr>
        <p:blipFill rotWithShape="1">
          <a:blip r:embed="rId3" cstate="print"/>
          <a:srcRect l="8240" t="61242" r="4611" b="3423"/>
          <a:stretch/>
        </p:blipFill>
        <p:spPr bwMode="auto">
          <a:xfrm>
            <a:off x="330200" y="1016000"/>
            <a:ext cx="8483600" cy="482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143000"/>
          </a:xfrm>
        </p:spPr>
        <p:txBody>
          <a:bodyPr/>
          <a:lstStyle/>
          <a:p>
            <a:r>
              <a:rPr lang="en-US" dirty="0"/>
              <a:t>Patient interface (1)</a:t>
            </a:r>
          </a:p>
        </p:txBody>
      </p:sp>
    </p:spTree>
    <p:extLst>
      <p:ext uri="{BB962C8B-B14F-4D97-AF65-F5344CB8AC3E}">
        <p14:creationId xmlns:p14="http://schemas.microsoft.com/office/powerpoint/2010/main" val="22285935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5"/>
          <p:cNvPicPr>
            <a:picLocks noChangeAspect="1" noChangeArrowheads="1"/>
          </p:cNvPicPr>
          <p:nvPr/>
        </p:nvPicPr>
        <p:blipFill rotWithShape="1">
          <a:blip r:embed="rId2" cstate="print"/>
          <a:srcRect l="8297" t="61408" r="4551" b="3344"/>
          <a:stretch/>
        </p:blipFill>
        <p:spPr bwMode="auto">
          <a:xfrm>
            <a:off x="330201" y="1022350"/>
            <a:ext cx="8483599" cy="4813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143000"/>
          </a:xfrm>
        </p:spPr>
        <p:txBody>
          <a:bodyPr/>
          <a:lstStyle/>
          <a:p>
            <a:r>
              <a:rPr lang="en-US" dirty="0"/>
              <a:t>Patient interface (2)</a:t>
            </a:r>
          </a:p>
        </p:txBody>
      </p:sp>
    </p:spTree>
    <p:extLst>
      <p:ext uri="{BB962C8B-B14F-4D97-AF65-F5344CB8AC3E}">
        <p14:creationId xmlns:p14="http://schemas.microsoft.com/office/powerpoint/2010/main" val="21270828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201988" y="6322368"/>
            <a:ext cx="47625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1200" dirty="0" err="1">
                <a:solidFill>
                  <a:schemeClr val="bg1"/>
                </a:solidFill>
                <a:latin typeface="Helvetica Neue"/>
              </a:rPr>
              <a:t>Mackillop</a:t>
            </a:r>
            <a:r>
              <a:rPr lang="en-GB" sz="1200" dirty="0">
                <a:solidFill>
                  <a:schemeClr val="bg1"/>
                </a:solidFill>
                <a:latin typeface="Helvetica Neue"/>
              </a:rPr>
              <a:t> et al. J Diabetes </a:t>
            </a:r>
            <a:r>
              <a:rPr lang="en-GB" sz="1200" dirty="0" err="1">
                <a:solidFill>
                  <a:schemeClr val="bg1"/>
                </a:solidFill>
                <a:latin typeface="Helvetica Neue"/>
              </a:rPr>
              <a:t>Sci</a:t>
            </a:r>
            <a:r>
              <a:rPr lang="en-GB" sz="1200" dirty="0">
                <a:solidFill>
                  <a:schemeClr val="bg1"/>
                </a:solidFill>
                <a:latin typeface="Helvetica Neue"/>
              </a:rPr>
              <a:t> </a:t>
            </a:r>
            <a:r>
              <a:rPr lang="en-GB" sz="1200" dirty="0" err="1">
                <a:solidFill>
                  <a:schemeClr val="bg1"/>
                </a:solidFill>
                <a:latin typeface="Helvetica Neue"/>
              </a:rPr>
              <a:t>Technol</a:t>
            </a:r>
            <a:r>
              <a:rPr lang="en-GB" sz="1200" dirty="0">
                <a:solidFill>
                  <a:schemeClr val="bg1"/>
                </a:solidFill>
                <a:latin typeface="Helvetica Neue"/>
              </a:rPr>
              <a:t> 2014; 8 (6): 1105-1114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154097" y="1260629"/>
            <a:ext cx="7173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grpSp>
        <p:nvGrpSpPr>
          <p:cNvPr id="80" name="Group 79"/>
          <p:cNvGrpSpPr/>
          <p:nvPr/>
        </p:nvGrpSpPr>
        <p:grpSpPr>
          <a:xfrm>
            <a:off x="593966" y="395071"/>
            <a:ext cx="4046941" cy="5361277"/>
            <a:chOff x="0" y="1688141"/>
            <a:chExt cx="9584595" cy="11111289"/>
          </a:xfrm>
        </p:grpSpPr>
        <p:grpSp>
          <p:nvGrpSpPr>
            <p:cNvPr id="82" name="Group 81"/>
            <p:cNvGrpSpPr/>
            <p:nvPr/>
          </p:nvGrpSpPr>
          <p:grpSpPr>
            <a:xfrm>
              <a:off x="0" y="8851361"/>
              <a:ext cx="1999597" cy="2253302"/>
              <a:chOff x="0" y="8851361"/>
              <a:chExt cx="1999597" cy="2253302"/>
            </a:xfrm>
          </p:grpSpPr>
          <p:pic>
            <p:nvPicPr>
              <p:cNvPr id="115" name="Picture 114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8851361"/>
                <a:ext cx="1999597" cy="225330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16" name="Picture 115" descr="http://mentalhealthcop.files.wordpress.com/2012/02/nhs1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640600">
                <a:off x="714415" y="10439008"/>
                <a:ext cx="446012" cy="2955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83" name="TextBox 16"/>
            <p:cNvSpPr txBox="1"/>
            <p:nvPr/>
          </p:nvSpPr>
          <p:spPr>
            <a:xfrm>
              <a:off x="2772170" y="6292864"/>
              <a:ext cx="3228568" cy="92972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Bluetooth </a:t>
              </a:r>
              <a:endParaRPr lang="en-GB" sz="9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Glucose Meter Accessory</a:t>
              </a:r>
              <a:endParaRPr lang="en-GB" sz="9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(</a:t>
              </a:r>
              <a:r>
                <a:rPr lang="en-US" sz="900" kern="1200" dirty="0" err="1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Polymap</a:t>
              </a: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 LLC)</a:t>
              </a:r>
              <a:endParaRPr lang="en-GB" sz="9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84" name="TextBox 17"/>
            <p:cNvSpPr txBox="1"/>
            <p:nvPr/>
          </p:nvSpPr>
          <p:spPr>
            <a:xfrm>
              <a:off x="264054" y="6460849"/>
              <a:ext cx="1867700" cy="92973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OneTouch </a:t>
              </a:r>
              <a:r>
                <a:rPr lang="en-US" sz="900" kern="1200" dirty="0" err="1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UltraEasy</a:t>
              </a:r>
              <a:endParaRPr lang="en-GB" sz="5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(</a:t>
              </a:r>
              <a:r>
                <a:rPr lang="en-US" sz="900" kern="1200" dirty="0" err="1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Lifescan</a:t>
              </a: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 Inc.)</a:t>
              </a:r>
              <a:endParaRPr lang="en-GB" sz="5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85" name="TextBox 78"/>
            <p:cNvSpPr txBox="1"/>
            <p:nvPr/>
          </p:nvSpPr>
          <p:spPr>
            <a:xfrm>
              <a:off x="6218773" y="6601160"/>
              <a:ext cx="1709147" cy="64910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900" kern="1200" dirty="0">
                  <a:solidFill>
                    <a:srgbClr val="002147"/>
                  </a:solidFill>
                  <a:effectLst/>
                  <a:latin typeface="Helvetica Neue"/>
                  <a:ea typeface="Times New Roman"/>
                  <a:cs typeface="Helvetica Neue"/>
                </a:rPr>
                <a:t>Android mobile phone with app</a:t>
              </a:r>
              <a:endParaRPr lang="en-GB" sz="500" dirty="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86" name="Straight Arrow Connector 85"/>
            <p:cNvCxnSpPr/>
            <p:nvPr/>
          </p:nvCxnSpPr>
          <p:spPr>
            <a:xfrm>
              <a:off x="4930773" y="4856092"/>
              <a:ext cx="1095076" cy="0"/>
            </a:xfrm>
            <a:prstGeom prst="straightConnector1">
              <a:avLst/>
            </a:prstGeom>
            <a:ln w="38100"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7" name="Picture 86" descr="http://windows8installation.com/wp-content/uploads/2012/03/BlueTooth.pn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92107" y="4568060"/>
              <a:ext cx="551383" cy="5513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8" name="Rectangle 87"/>
            <p:cNvSpPr/>
            <p:nvPr/>
          </p:nvSpPr>
          <p:spPr>
            <a:xfrm>
              <a:off x="4903834" y="8960338"/>
              <a:ext cx="2016041" cy="761354"/>
            </a:xfrm>
            <a:prstGeom prst="rect">
              <a:avLst/>
            </a:prstGeom>
            <a:noFill/>
          </p:spPr>
          <p:txBody>
            <a:bodyPr wrap="square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7F7F7F"/>
                  </a:solidFill>
                  <a:effectLst/>
                  <a:latin typeface="Helvetica Neue"/>
                  <a:ea typeface="Times New Roman"/>
                  <a:cs typeface="Helvetica Neue"/>
                </a:rPr>
                <a:t>TEXT</a:t>
              </a:r>
              <a:endParaRPr lang="en-GB" sz="5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7F7F7F"/>
                  </a:solidFill>
                  <a:effectLst/>
                  <a:latin typeface="Helvetica Neue"/>
                  <a:ea typeface="Times New Roman"/>
                  <a:cs typeface="Helvetica Neue"/>
                </a:rPr>
                <a:t>MESSAGES</a:t>
              </a:r>
              <a:endParaRPr lang="en-GB" sz="500" dirty="0">
                <a:effectLst/>
                <a:latin typeface="Times New Roman"/>
                <a:ea typeface="Times New Roman"/>
              </a:endParaRPr>
            </a:p>
          </p:txBody>
        </p:sp>
        <p:grpSp>
          <p:nvGrpSpPr>
            <p:cNvPr id="89" name="Group 88"/>
            <p:cNvGrpSpPr/>
            <p:nvPr/>
          </p:nvGrpSpPr>
          <p:grpSpPr>
            <a:xfrm>
              <a:off x="5669502" y="8784976"/>
              <a:ext cx="3699069" cy="4014454"/>
              <a:chOff x="5669502" y="8784976"/>
              <a:chExt cx="3699069" cy="4014454"/>
            </a:xfrm>
          </p:grpSpPr>
          <p:grpSp>
            <p:nvGrpSpPr>
              <p:cNvPr id="110" name="Group 109"/>
              <p:cNvGrpSpPr>
                <a:grpSpLocks noChangeAspect="1"/>
              </p:cNvGrpSpPr>
              <p:nvPr/>
            </p:nvGrpSpPr>
            <p:grpSpPr>
              <a:xfrm>
                <a:off x="5669502" y="9688172"/>
                <a:ext cx="3074648" cy="3111258"/>
                <a:chOff x="5669502" y="9688172"/>
                <a:chExt cx="3501361" cy="3543049"/>
              </a:xfrm>
            </p:grpSpPr>
            <p:pic>
              <p:nvPicPr>
                <p:cNvPr id="113" name="Picture 112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clrChange>
                    <a:clrFrom>
                      <a:srgbClr val="FEFEFE"/>
                    </a:clrFrom>
                    <a:clrTo>
                      <a:srgbClr val="FEFEFE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021" t="27019" r="1123" b="20301"/>
                <a:stretch/>
              </p:blipFill>
              <p:spPr>
                <a:xfrm>
                  <a:off x="6625411" y="9688172"/>
                  <a:ext cx="2545452" cy="3543049"/>
                </a:xfrm>
                <a:prstGeom prst="rect">
                  <a:avLst/>
                </a:prstGeom>
              </p:spPr>
            </p:pic>
            <p:sp>
              <p:nvSpPr>
                <p:cNvPr id="114" name="Rectangle 113"/>
                <p:cNvSpPr/>
                <p:nvPr/>
              </p:nvSpPr>
              <p:spPr>
                <a:xfrm>
                  <a:off x="5669502" y="9688172"/>
                  <a:ext cx="1800200" cy="32403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n-GB"/>
                </a:p>
              </p:txBody>
            </p:sp>
          </p:grpSp>
          <p:sp>
            <p:nvSpPr>
              <p:cNvPr id="111" name="TextBox 74"/>
              <p:cNvSpPr txBox="1"/>
              <p:nvPr/>
            </p:nvSpPr>
            <p:spPr>
              <a:xfrm>
                <a:off x="6942530" y="9688172"/>
                <a:ext cx="1276536" cy="400110"/>
              </a:xfrm>
              <a:custGeom>
                <a:avLst/>
                <a:gdLst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162003 w 1067650"/>
                  <a:gd name="connsiteY6" fmla="*/ 972000 h 972000"/>
                  <a:gd name="connsiteX7" fmla="*/ 0 w 1067650"/>
                  <a:gd name="connsiteY7" fmla="*/ 809997 h 972000"/>
                  <a:gd name="connsiteX8" fmla="*/ 0 w 1067650"/>
                  <a:gd name="connsiteY8" fmla="*/ 162003 h 972000"/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220060 w 1067650"/>
                  <a:gd name="connsiteY6" fmla="*/ 884915 h 972000"/>
                  <a:gd name="connsiteX7" fmla="*/ 0 w 1067650"/>
                  <a:gd name="connsiteY7" fmla="*/ 809997 h 972000"/>
                  <a:gd name="connsiteX8" fmla="*/ 0 w 1067650"/>
                  <a:gd name="connsiteY8" fmla="*/ 162003 h 972000"/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132975 w 1067650"/>
                  <a:gd name="connsiteY6" fmla="*/ 957486 h 972000"/>
                  <a:gd name="connsiteX7" fmla="*/ 0 w 1067650"/>
                  <a:gd name="connsiteY7" fmla="*/ 809997 h 972000"/>
                  <a:gd name="connsiteX8" fmla="*/ 0 w 1067650"/>
                  <a:gd name="connsiteY8" fmla="*/ 162003 h 972000"/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132975 w 1067650"/>
                  <a:gd name="connsiteY6" fmla="*/ 957486 h 972000"/>
                  <a:gd name="connsiteX7" fmla="*/ 87085 w 1067650"/>
                  <a:gd name="connsiteY7" fmla="*/ 780969 h 972000"/>
                  <a:gd name="connsiteX8" fmla="*/ 0 w 1067650"/>
                  <a:gd name="connsiteY8" fmla="*/ 162003 h 972000"/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132975 w 1067650"/>
                  <a:gd name="connsiteY6" fmla="*/ 957486 h 972000"/>
                  <a:gd name="connsiteX7" fmla="*/ 87085 w 1067650"/>
                  <a:gd name="connsiteY7" fmla="*/ 780969 h 972000"/>
                  <a:gd name="connsiteX8" fmla="*/ 0 w 1067650"/>
                  <a:gd name="connsiteY8" fmla="*/ 162003 h 972000"/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132975 w 1067650"/>
                  <a:gd name="connsiteY6" fmla="*/ 957486 h 972000"/>
                  <a:gd name="connsiteX7" fmla="*/ 87085 w 1067650"/>
                  <a:gd name="connsiteY7" fmla="*/ 780969 h 972000"/>
                  <a:gd name="connsiteX8" fmla="*/ 0 w 1067650"/>
                  <a:gd name="connsiteY8" fmla="*/ 162003 h 972000"/>
                  <a:gd name="connsiteX0" fmla="*/ 0 w 1067650"/>
                  <a:gd name="connsiteY0" fmla="*/ 162003 h 972000"/>
                  <a:gd name="connsiteX1" fmla="*/ 162003 w 1067650"/>
                  <a:gd name="connsiteY1" fmla="*/ 0 h 972000"/>
                  <a:gd name="connsiteX2" fmla="*/ 905647 w 1067650"/>
                  <a:gd name="connsiteY2" fmla="*/ 0 h 972000"/>
                  <a:gd name="connsiteX3" fmla="*/ 1067650 w 1067650"/>
                  <a:gd name="connsiteY3" fmla="*/ 162003 h 972000"/>
                  <a:gd name="connsiteX4" fmla="*/ 1067650 w 1067650"/>
                  <a:gd name="connsiteY4" fmla="*/ 809997 h 972000"/>
                  <a:gd name="connsiteX5" fmla="*/ 905647 w 1067650"/>
                  <a:gd name="connsiteY5" fmla="*/ 972000 h 972000"/>
                  <a:gd name="connsiteX6" fmla="*/ 176518 w 1067650"/>
                  <a:gd name="connsiteY6" fmla="*/ 899429 h 972000"/>
                  <a:gd name="connsiteX7" fmla="*/ 87085 w 1067650"/>
                  <a:gd name="connsiteY7" fmla="*/ 780969 h 972000"/>
                  <a:gd name="connsiteX8" fmla="*/ 0 w 1067650"/>
                  <a:gd name="connsiteY8" fmla="*/ 162003 h 972000"/>
                  <a:gd name="connsiteX0" fmla="*/ 0 w 1067650"/>
                  <a:gd name="connsiteY0" fmla="*/ 162003 h 975838"/>
                  <a:gd name="connsiteX1" fmla="*/ 162003 w 1067650"/>
                  <a:gd name="connsiteY1" fmla="*/ 0 h 975838"/>
                  <a:gd name="connsiteX2" fmla="*/ 905647 w 1067650"/>
                  <a:gd name="connsiteY2" fmla="*/ 0 h 975838"/>
                  <a:gd name="connsiteX3" fmla="*/ 1067650 w 1067650"/>
                  <a:gd name="connsiteY3" fmla="*/ 162003 h 975838"/>
                  <a:gd name="connsiteX4" fmla="*/ 1067650 w 1067650"/>
                  <a:gd name="connsiteY4" fmla="*/ 809997 h 975838"/>
                  <a:gd name="connsiteX5" fmla="*/ 905647 w 1067650"/>
                  <a:gd name="connsiteY5" fmla="*/ 972000 h 975838"/>
                  <a:gd name="connsiteX6" fmla="*/ 176518 w 1067650"/>
                  <a:gd name="connsiteY6" fmla="*/ 899429 h 975838"/>
                  <a:gd name="connsiteX7" fmla="*/ 87085 w 1067650"/>
                  <a:gd name="connsiteY7" fmla="*/ 780969 h 975838"/>
                  <a:gd name="connsiteX8" fmla="*/ 0 w 1067650"/>
                  <a:gd name="connsiteY8" fmla="*/ 162003 h 9758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1067650" h="975838">
                    <a:moveTo>
                      <a:pt x="0" y="162003"/>
                    </a:moveTo>
                    <a:cubicBezTo>
                      <a:pt x="0" y="72531"/>
                      <a:pt x="72531" y="0"/>
                      <a:pt x="162003" y="0"/>
                    </a:cubicBezTo>
                    <a:lnTo>
                      <a:pt x="905647" y="0"/>
                    </a:lnTo>
                    <a:cubicBezTo>
                      <a:pt x="995119" y="0"/>
                      <a:pt x="1067650" y="72531"/>
                      <a:pt x="1067650" y="162003"/>
                    </a:cubicBezTo>
                    <a:lnTo>
                      <a:pt x="1067650" y="809997"/>
                    </a:lnTo>
                    <a:cubicBezTo>
                      <a:pt x="1067650" y="899469"/>
                      <a:pt x="995119" y="972000"/>
                      <a:pt x="905647" y="972000"/>
                    </a:cubicBezTo>
                    <a:cubicBezTo>
                      <a:pt x="657766" y="972000"/>
                      <a:pt x="264742" y="1001029"/>
                      <a:pt x="176518" y="899429"/>
                    </a:cubicBezTo>
                    <a:cubicBezTo>
                      <a:pt x="87046" y="899429"/>
                      <a:pt x="188685" y="797870"/>
                      <a:pt x="87085" y="780969"/>
                    </a:cubicBezTo>
                    <a:cubicBezTo>
                      <a:pt x="29028" y="632704"/>
                      <a:pt x="29028" y="368325"/>
                      <a:pt x="0" y="162003"/>
                    </a:cubicBezTo>
                    <a:close/>
                  </a:path>
                </a:pathLst>
              </a:custGeom>
              <a:ln w="28575">
                <a:noFill/>
              </a:ln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wrap="square" rtlCol="0">
                <a:noAutofit/>
              </a:bodyPr>
              <a:lstStyle/>
              <a:p>
                <a:endParaRPr lang="en-GB"/>
              </a:p>
            </p:txBody>
          </p:sp>
          <p:pic>
            <p:nvPicPr>
              <p:cNvPr id="112" name="Picture 111" descr="C:\Documents and Settings\Oliver\My Documents\mHealth\Publications\DiabetesTechnology2012\GDm-Health\nurse_256_edited.png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7424571" y="8784976"/>
                <a:ext cx="1944000" cy="1944000"/>
              </a:xfrm>
              <a:prstGeom prst="rect">
                <a:avLst/>
              </a:prstGeom>
              <a:noFill/>
            </p:spPr>
          </p:pic>
        </p:grpSp>
        <p:grpSp>
          <p:nvGrpSpPr>
            <p:cNvPr id="90" name="Group 89"/>
            <p:cNvGrpSpPr/>
            <p:nvPr/>
          </p:nvGrpSpPr>
          <p:grpSpPr>
            <a:xfrm>
              <a:off x="347898" y="2798898"/>
              <a:ext cx="4848548" cy="4184639"/>
              <a:chOff x="347898" y="2798898"/>
              <a:chExt cx="4848548" cy="4184639"/>
            </a:xfrm>
          </p:grpSpPr>
          <p:pic>
            <p:nvPicPr>
              <p:cNvPr id="108" name="Picture 107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7898" y="2798898"/>
                <a:ext cx="4848548" cy="4184639"/>
              </a:xfrm>
              <a:prstGeom prst="rect">
                <a:avLst/>
              </a:prstGeom>
            </p:spPr>
          </p:pic>
          <p:sp>
            <p:nvSpPr>
              <p:cNvPr id="109" name="Rectangle 108"/>
              <p:cNvSpPr/>
              <p:nvPr/>
            </p:nvSpPr>
            <p:spPr>
              <a:xfrm>
                <a:off x="1163998" y="2798898"/>
                <a:ext cx="207080" cy="4010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/>
              </a:p>
            </p:txBody>
          </p:sp>
        </p:grpSp>
        <p:cxnSp>
          <p:nvCxnSpPr>
            <p:cNvPr id="91" name="Straight Arrow Connector 90"/>
            <p:cNvCxnSpPr/>
            <p:nvPr/>
          </p:nvCxnSpPr>
          <p:spPr>
            <a:xfrm flipH="1">
              <a:off x="1735723" y="10578085"/>
              <a:ext cx="4466020" cy="0"/>
            </a:xfrm>
            <a:prstGeom prst="straightConnector1">
              <a:avLst/>
            </a:prstGeom>
            <a:ln w="28575">
              <a:solidFill>
                <a:schemeClr val="bg1">
                  <a:lumMod val="75000"/>
                </a:schemeClr>
              </a:solidFill>
              <a:prstDash val="sysDash"/>
              <a:headEnd type="arrow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Arrow Connector 91"/>
            <p:cNvCxnSpPr/>
            <p:nvPr/>
          </p:nvCxnSpPr>
          <p:spPr>
            <a:xfrm flipH="1">
              <a:off x="1308701" y="8329210"/>
              <a:ext cx="5693635" cy="0"/>
            </a:xfrm>
            <a:prstGeom prst="straightConnector1">
              <a:avLst/>
            </a:prstGeom>
            <a:ln w="28575">
              <a:solidFill>
                <a:schemeClr val="bg1">
                  <a:lumMod val="75000"/>
                </a:schemeClr>
              </a:solidFill>
              <a:prstDash val="sys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Arrow Connector 92"/>
            <p:cNvCxnSpPr/>
            <p:nvPr/>
          </p:nvCxnSpPr>
          <p:spPr>
            <a:xfrm>
              <a:off x="6999011" y="7926578"/>
              <a:ext cx="0" cy="402632"/>
            </a:xfrm>
            <a:prstGeom prst="straightConnector1">
              <a:avLst/>
            </a:prstGeom>
            <a:ln w="28575">
              <a:solidFill>
                <a:schemeClr val="bg1">
                  <a:lumMod val="75000"/>
                </a:schemeClr>
              </a:solidFill>
              <a:prstDash val="sys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Arrow Connector 93"/>
            <p:cNvCxnSpPr/>
            <p:nvPr/>
          </p:nvCxnSpPr>
          <p:spPr>
            <a:xfrm>
              <a:off x="1308701" y="8329210"/>
              <a:ext cx="0" cy="455766"/>
            </a:xfrm>
            <a:prstGeom prst="straightConnector1">
              <a:avLst/>
            </a:prstGeom>
            <a:ln w="28575">
              <a:solidFill>
                <a:schemeClr val="bg1">
                  <a:lumMod val="75000"/>
                </a:schemeClr>
              </a:solidFill>
              <a:prstDash val="sysDash"/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Arrow Connector 94"/>
            <p:cNvCxnSpPr/>
            <p:nvPr/>
          </p:nvCxnSpPr>
          <p:spPr>
            <a:xfrm flipH="1">
              <a:off x="7152111" y="7926578"/>
              <a:ext cx="0" cy="2036517"/>
            </a:xfrm>
            <a:prstGeom prst="straightConnector1">
              <a:avLst/>
            </a:prstGeom>
            <a:ln w="28575">
              <a:solidFill>
                <a:schemeClr val="bg1">
                  <a:lumMod val="75000"/>
                </a:schemeClr>
              </a:solidFill>
              <a:prstDash val="sysDash"/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6" name="Group 95"/>
            <p:cNvGrpSpPr/>
            <p:nvPr/>
          </p:nvGrpSpPr>
          <p:grpSpPr>
            <a:xfrm>
              <a:off x="3895963" y="10328459"/>
              <a:ext cx="1668407" cy="632601"/>
              <a:chOff x="3895963" y="10328459"/>
              <a:chExt cx="1668407" cy="632601"/>
            </a:xfrm>
          </p:grpSpPr>
          <p:sp>
            <p:nvSpPr>
              <p:cNvPr id="105" name="Rectangle 104"/>
              <p:cNvSpPr/>
              <p:nvPr/>
            </p:nvSpPr>
            <p:spPr>
              <a:xfrm>
                <a:off x="3895963" y="10340312"/>
                <a:ext cx="829119" cy="4336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106" name="Rectangle 105"/>
              <p:cNvSpPr/>
              <p:nvPr/>
            </p:nvSpPr>
            <p:spPr>
              <a:xfrm>
                <a:off x="4373248" y="10328459"/>
                <a:ext cx="1191122" cy="63260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sz="900" b="1" kern="1200" dirty="0">
                    <a:solidFill>
                      <a:srgbClr val="7F7F7F"/>
                    </a:solidFill>
                    <a:effectLst/>
                    <a:latin typeface="Helvetica Neue"/>
                    <a:ea typeface="Times New Roman"/>
                    <a:cs typeface="Helvetica Neue"/>
                  </a:rPr>
                  <a:t>Wi-Fi</a:t>
                </a:r>
                <a:endParaRPr lang="en-GB" sz="500" dirty="0">
                  <a:effectLst/>
                  <a:latin typeface="Times New Roman"/>
                  <a:ea typeface="Times New Roman"/>
                </a:endParaRPr>
              </a:p>
            </p:txBody>
          </p:sp>
          <p:pic>
            <p:nvPicPr>
              <p:cNvPr id="107" name="Picture 106" descr="http://www.clker.com/cliparts/9/p/9/h/t/P/free-wifi-sign-hi.png">
                <a:hlinkClick r:id="rId8"/>
              </p:cNvPr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8909"/>
              <a:stretch/>
            </p:blipFill>
            <p:spPr bwMode="auto">
              <a:xfrm>
                <a:off x="3895964" y="10403326"/>
                <a:ext cx="416662" cy="37067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97" name="Picture 96" descr="http://desertluxuryrealty.com/wp-content/uploads/2012/08/email-letter-icon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99" t="14730" r="12979" b="18243"/>
            <a:stretch/>
          </p:blipFill>
          <p:spPr bwMode="auto">
            <a:xfrm>
              <a:off x="6758179" y="9032556"/>
              <a:ext cx="720080" cy="5165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8" name="Rectangle 97"/>
            <p:cNvSpPr/>
            <p:nvPr/>
          </p:nvSpPr>
          <p:spPr>
            <a:xfrm>
              <a:off x="3548832" y="7992701"/>
              <a:ext cx="1859101" cy="7613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900" b="1" kern="1200" dirty="0">
                  <a:solidFill>
                    <a:srgbClr val="7F7F7F"/>
                  </a:solidFill>
                  <a:effectLst/>
                  <a:latin typeface="Helvetica Neue"/>
                  <a:ea typeface="Times New Roman"/>
                  <a:cs typeface="Helvetica Neue"/>
                </a:rPr>
                <a:t>MOBILE</a:t>
              </a:r>
              <a:endParaRPr lang="en-GB" sz="400" dirty="0">
                <a:effectLst/>
                <a:latin typeface="Times New Roman"/>
                <a:ea typeface="Times New Roman"/>
              </a:endParaRPr>
            </a:p>
            <a:p>
              <a:pPr algn="ctr">
                <a:spcAft>
                  <a:spcPts val="0"/>
                </a:spcAft>
              </a:pPr>
              <a:r>
                <a:rPr lang="en-US" sz="900" b="1" kern="1200" dirty="0">
                  <a:solidFill>
                    <a:srgbClr val="7F7F7F"/>
                  </a:solidFill>
                  <a:effectLst/>
                  <a:latin typeface="Helvetica Neue"/>
                  <a:ea typeface="Times New Roman"/>
                  <a:cs typeface="Helvetica Neue"/>
                </a:rPr>
                <a:t>INTERNET</a:t>
              </a:r>
              <a:endParaRPr lang="en-GB" sz="400" dirty="0">
                <a:effectLst/>
                <a:latin typeface="Times New Roman"/>
                <a:ea typeface="Times New Roman"/>
              </a:endParaRPr>
            </a:p>
          </p:txBody>
        </p:sp>
        <p:pic>
          <p:nvPicPr>
            <p:cNvPr id="99" name="Picture 98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99356" y="7952436"/>
              <a:ext cx="1108575" cy="15000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1" name="Picture 100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86818" y="3108960"/>
              <a:ext cx="2160240" cy="3462182"/>
            </a:xfrm>
            <a:prstGeom prst="rect">
              <a:avLst/>
            </a:prstGeom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102" name="Picture 101" descr="C:\Documents and Settings\Oliver\My Documents\mHealth\Publications\DiabetesTechnology2012\GDm-Health\pregnant_256.png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7558306" y="1688141"/>
              <a:ext cx="2026289" cy="1944000"/>
            </a:xfrm>
            <a:prstGeom prst="rect">
              <a:avLst/>
            </a:prstGeom>
            <a:noFill/>
          </p:spPr>
        </p:pic>
        <p:pic>
          <p:nvPicPr>
            <p:cNvPr id="103" name="Picture 102" descr="E:\dcim\2013-09-12_04-28-54.png"/>
            <p:cNvPicPr>
              <a:picLocks noChangeAspect="1" noChangeArrowheads="1"/>
            </p:cNvPicPr>
            <p:nvPr/>
          </p:nvPicPr>
          <p:blipFill>
            <a:blip r:embed="rId14"/>
            <a:srcRect t="4906"/>
            <a:stretch>
              <a:fillRect/>
            </a:stretch>
          </p:blipFill>
          <p:spPr bwMode="auto">
            <a:xfrm rot="60000">
              <a:off x="6288369" y="3542354"/>
              <a:ext cx="1620000" cy="2310794"/>
            </a:xfrm>
            <a:prstGeom prst="rect">
              <a:avLst/>
            </a:prstGeom>
            <a:noFill/>
          </p:spPr>
        </p:pic>
      </p:grpSp>
      <p:sp>
        <p:nvSpPr>
          <p:cNvPr id="38" name="Rectangle 37"/>
          <p:cNvSpPr/>
          <p:nvPr/>
        </p:nvSpPr>
        <p:spPr>
          <a:xfrm>
            <a:off x="4640907" y="1401358"/>
            <a:ext cx="4182511" cy="2954645"/>
          </a:xfrm>
          <a:prstGeom prst="rect">
            <a:avLst/>
          </a:prstGeom>
        </p:spPr>
        <p:txBody>
          <a:bodyPr wrap="square" lIns="91429" tIns="45715" rIns="91429" bIns="45715">
            <a:spAutoFit/>
          </a:bodyPr>
          <a:lstStyle/>
          <a:p>
            <a:r>
              <a:rPr lang="en-GB" sz="2400" dirty="0"/>
              <a:t>Advantages:</a:t>
            </a:r>
          </a:p>
          <a:p>
            <a:pPr lvl="1">
              <a:buClr>
                <a:schemeClr val="accent3"/>
              </a:buClr>
              <a:buFont typeface="Wingdings" charset="2"/>
              <a:buChar char="ü"/>
            </a:pPr>
            <a:r>
              <a:rPr lang="en-GB" dirty="0"/>
              <a:t>Electronic transfer of data</a:t>
            </a:r>
          </a:p>
          <a:p>
            <a:pPr lvl="1">
              <a:buClr>
                <a:schemeClr val="accent3"/>
              </a:buClr>
              <a:buFont typeface="Wingdings" charset="2"/>
              <a:buChar char="ü"/>
            </a:pPr>
            <a:r>
              <a:rPr lang="en-GB" dirty="0"/>
              <a:t>Real-time transmission </a:t>
            </a:r>
          </a:p>
          <a:p>
            <a:pPr lvl="1">
              <a:buClr>
                <a:schemeClr val="accent3"/>
              </a:buClr>
              <a:buFont typeface="Wingdings" charset="2"/>
              <a:buChar char="ü"/>
            </a:pPr>
            <a:r>
              <a:rPr lang="en-GB" dirty="0"/>
              <a:t>Real-time feedback</a:t>
            </a:r>
          </a:p>
          <a:p>
            <a:pPr lvl="1">
              <a:buClr>
                <a:schemeClr val="accent3"/>
              </a:buClr>
              <a:buFont typeface="Wingdings" charset="2"/>
              <a:buChar char="ü"/>
            </a:pPr>
            <a:r>
              <a:rPr lang="en-GB" dirty="0"/>
              <a:t>Prioritisation of patients who require extra support/intervention</a:t>
            </a:r>
          </a:p>
          <a:p>
            <a:pPr lvl="1">
              <a:buClr>
                <a:schemeClr val="accent3"/>
              </a:buClr>
              <a:buFont typeface="Wingdings" charset="2"/>
              <a:buChar char="ü"/>
            </a:pPr>
            <a:r>
              <a:rPr lang="en-GB" dirty="0"/>
              <a:t>Facilitates team-based working</a:t>
            </a:r>
          </a:p>
          <a:p>
            <a:pPr lvl="1">
              <a:buClr>
                <a:schemeClr val="accent3"/>
              </a:buClr>
              <a:buFont typeface="Wingdings" charset="2"/>
              <a:buChar char="ü"/>
            </a:pPr>
            <a:r>
              <a:rPr lang="en-GB" dirty="0"/>
              <a:t>BGs and other information recorded electronically – facilitates meaningful audit</a:t>
            </a:r>
          </a:p>
        </p:txBody>
      </p:sp>
    </p:spTree>
    <p:extLst>
      <p:ext uri="{BB962C8B-B14F-4D97-AF65-F5344CB8AC3E}">
        <p14:creationId xmlns:p14="http://schemas.microsoft.com/office/powerpoint/2010/main" val="4015139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0</TotalTime>
  <Words>309</Words>
  <Application>Microsoft Macintosh PowerPoint</Application>
  <PresentationFormat>On-screen Show (4:3)</PresentationFormat>
  <Paragraphs>61</Paragraphs>
  <Slides>7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Helvetica Neue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  <vt:lpstr>Blood glucose diaries</vt:lpstr>
      <vt:lpstr>Patient interface (1)</vt:lpstr>
      <vt:lpstr>Patient interface (2)</vt:lpstr>
      <vt:lpstr>PowerPoint Presentation</vt:lpstr>
    </vt:vector>
  </TitlesOfParts>
  <LinksUpToDate>false</LinksUpToDate>
  <SharedDoc>false</SharedDoc>
  <HyperlinksChanged>false</HyperlinksChanged>
  <AppVersion>16.001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y Mackillop</dc:creator>
  <cp:lastModifiedBy>Lucy Mackillop</cp:lastModifiedBy>
  <cp:revision>46</cp:revision>
  <dcterms:created xsi:type="dcterms:W3CDTF">2017-04-11T20:13:36Z</dcterms:created>
  <dcterms:modified xsi:type="dcterms:W3CDTF">2018-02-19T09:47:54Z</dcterms:modified>
</cp:coreProperties>
</file>